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60" r:id="rId4"/>
    <p:sldId id="258" r:id="rId5"/>
    <p:sldId id="259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92" autoAdjust="0"/>
    <p:restoredTop sz="94660"/>
  </p:normalViewPr>
  <p:slideViewPr>
    <p:cSldViewPr snapToGrid="0" showGuides="1">
      <p:cViewPr>
        <p:scale>
          <a:sx n="119" d="100"/>
          <a:sy n="119" d="100"/>
        </p:scale>
        <p:origin x="1088" y="-8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6310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057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558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46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196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666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463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878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58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917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711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C23B0-EA72-4669-AC6C-AA05FA112E15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0E671-2FDB-4D58-824B-64E143069C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237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72979E0-7670-CF46-4592-5C72E548B06A}"/>
              </a:ext>
            </a:extLst>
          </p:cNvPr>
          <p:cNvSpPr txBox="1"/>
          <p:nvPr/>
        </p:nvSpPr>
        <p:spPr>
          <a:xfrm>
            <a:off x="514349" y="400050"/>
            <a:ext cx="3709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1. slow MyHC, fast MyH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6" name="グループ化 105">
            <a:extLst>
              <a:ext uri="{FF2B5EF4-FFF2-40B4-BE49-F238E27FC236}">
                <a16:creationId xmlns:a16="http://schemas.microsoft.com/office/drawing/2014/main" id="{817E9004-E9FF-412F-8B57-B9C238A64AE7}"/>
              </a:ext>
            </a:extLst>
          </p:cNvPr>
          <p:cNvGrpSpPr/>
          <p:nvPr/>
        </p:nvGrpSpPr>
        <p:grpSpPr>
          <a:xfrm>
            <a:off x="572405" y="2997480"/>
            <a:ext cx="4578132" cy="887876"/>
            <a:chOff x="572405" y="2859596"/>
            <a:chExt cx="4578132" cy="887876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0925CA6-898F-D11A-44A4-E0B27D7B4F30}"/>
                </a:ext>
              </a:extLst>
            </p:cNvPr>
            <p:cNvSpPr txBox="1"/>
            <p:nvPr/>
          </p:nvSpPr>
          <p:spPr>
            <a:xfrm>
              <a:off x="572405" y="2859596"/>
              <a:ext cx="1128811" cy="492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ast MyHC</a:t>
              </a:r>
            </a:p>
            <a:p>
              <a:pPr algn="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200 </a:t>
              </a:r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図 18" descr="白い背景と黒い文字&#10;&#10;中程度の精度で自動的に生成された説明">
              <a:extLst>
                <a:ext uri="{FF2B5EF4-FFF2-40B4-BE49-F238E27FC236}">
                  <a16:creationId xmlns:a16="http://schemas.microsoft.com/office/drawing/2014/main" id="{752EAEDA-6885-AA23-6BF2-66884D2F43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730681" y="2859596"/>
              <a:ext cx="3419856" cy="887876"/>
            </a:xfrm>
            <a:prstGeom prst="rect">
              <a:avLst/>
            </a:prstGeom>
          </p:spPr>
        </p:pic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C57BD04-3D4E-C2C1-0420-73D688806D41}"/>
              </a:ext>
            </a:extLst>
          </p:cNvPr>
          <p:cNvSpPr txBox="1"/>
          <p:nvPr/>
        </p:nvSpPr>
        <p:spPr>
          <a:xfrm>
            <a:off x="406866" y="1978730"/>
            <a:ext cx="1294351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low MyHC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223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id="{36853BA5-0122-2AC1-8481-8AC52F432BEE}"/>
              </a:ext>
            </a:extLst>
          </p:cNvPr>
          <p:cNvGrpSpPr/>
          <p:nvPr/>
        </p:nvGrpSpPr>
        <p:grpSpPr>
          <a:xfrm>
            <a:off x="732476" y="4016230"/>
            <a:ext cx="4385623" cy="887876"/>
            <a:chOff x="732476" y="3696917"/>
            <a:chExt cx="4385623" cy="887876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639928B8-2993-7100-1AFD-F70C182C1ED0}"/>
                </a:ext>
              </a:extLst>
            </p:cNvPr>
            <p:cNvSpPr txBox="1"/>
            <p:nvPr/>
          </p:nvSpPr>
          <p:spPr>
            <a:xfrm>
              <a:off x="732476" y="3712306"/>
              <a:ext cx="968741" cy="52322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kumimoji="1" lang="en-US" altLang="ja-JP" sz="1600" b="1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pPr algn="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42 </a:t>
              </a:r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図 22" descr="煙, 飛行機, 空気, スポーツゲーム が含まれている画像&#10;&#10;自動的に生成された説明">
              <a:extLst>
                <a:ext uri="{FF2B5EF4-FFF2-40B4-BE49-F238E27FC236}">
                  <a16:creationId xmlns:a16="http://schemas.microsoft.com/office/drawing/2014/main" id="{2A06ADFB-1B1F-EF1B-AC32-F4B5C0C83B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98243" y="3696917"/>
              <a:ext cx="3419856" cy="887876"/>
            </a:xfrm>
            <a:prstGeom prst="rect">
              <a:avLst/>
            </a:prstGeom>
          </p:spPr>
        </p:pic>
      </p:grp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5232D005-606A-71E7-4464-11FF0601AF2D}"/>
              </a:ext>
            </a:extLst>
          </p:cNvPr>
          <p:cNvCxnSpPr>
            <a:cxnSpLocks/>
          </p:cNvCxnSpPr>
          <p:nvPr/>
        </p:nvCxnSpPr>
        <p:spPr>
          <a:xfrm>
            <a:off x="2396167" y="186261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E8397F6D-D97B-028C-BBD1-D8E3CA954CCF}"/>
              </a:ext>
            </a:extLst>
          </p:cNvPr>
          <p:cNvSpPr txBox="1"/>
          <p:nvPr/>
        </p:nvSpPr>
        <p:spPr>
          <a:xfrm>
            <a:off x="2494823" y="1598285"/>
            <a:ext cx="52268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B2F1C7CC-2CE6-E83F-CE2D-C47E5BDDFE67}"/>
              </a:ext>
            </a:extLst>
          </p:cNvPr>
          <p:cNvSpPr txBox="1"/>
          <p:nvPr/>
        </p:nvSpPr>
        <p:spPr>
          <a:xfrm>
            <a:off x="3167703" y="1598285"/>
            <a:ext cx="7326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2209EC12-7359-E572-7089-71611C48FDA3}"/>
              </a:ext>
            </a:extLst>
          </p:cNvPr>
          <p:cNvSpPr txBox="1"/>
          <p:nvPr/>
        </p:nvSpPr>
        <p:spPr>
          <a:xfrm>
            <a:off x="4034846" y="1591268"/>
            <a:ext cx="522687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20CBCAD-21F7-1E63-92DA-139077684371}"/>
              </a:ext>
            </a:extLst>
          </p:cNvPr>
          <p:cNvSpPr txBox="1"/>
          <p:nvPr/>
        </p:nvSpPr>
        <p:spPr>
          <a:xfrm>
            <a:off x="2742248" y="1223077"/>
            <a:ext cx="15313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elphinidin (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2A15025D-F489-DD7D-1E9A-89957D8F97D2}"/>
              </a:ext>
            </a:extLst>
          </p:cNvPr>
          <p:cNvCxnSpPr>
            <a:cxnSpLocks/>
          </p:cNvCxnSpPr>
          <p:nvPr/>
        </p:nvCxnSpPr>
        <p:spPr>
          <a:xfrm>
            <a:off x="3174003" y="186261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24753B5E-7C90-7C6B-FCD6-1FED4D8AF0B7}"/>
              </a:ext>
            </a:extLst>
          </p:cNvPr>
          <p:cNvCxnSpPr>
            <a:cxnSpLocks/>
          </p:cNvCxnSpPr>
          <p:nvPr/>
        </p:nvCxnSpPr>
        <p:spPr>
          <a:xfrm>
            <a:off x="3936190" y="186261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E65E86DD-350D-2D68-4E60-19C5D63EB4C8}"/>
              </a:ext>
            </a:extLst>
          </p:cNvPr>
          <p:cNvCxnSpPr>
            <a:cxnSpLocks/>
          </p:cNvCxnSpPr>
          <p:nvPr/>
        </p:nvCxnSpPr>
        <p:spPr>
          <a:xfrm>
            <a:off x="2607946" y="1553027"/>
            <a:ext cx="18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152463D-56FE-6790-9DE7-4E355CA19FDC}"/>
              </a:ext>
            </a:extLst>
          </p:cNvPr>
          <p:cNvSpPr txBox="1"/>
          <p:nvPr/>
        </p:nvSpPr>
        <p:spPr>
          <a:xfrm>
            <a:off x="5871438" y="3808481"/>
            <a:ext cx="341985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ta were analyzed using three representative samples excluding outliers.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FC1DF8A-460E-C8D8-0325-CFED3A957E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78439" y="2042828"/>
            <a:ext cx="2933700" cy="901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04372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5EA8D83-9FD0-E055-5A6E-282B7C0EB046}"/>
              </a:ext>
            </a:extLst>
          </p:cNvPr>
          <p:cNvSpPr txBox="1"/>
          <p:nvPr/>
        </p:nvSpPr>
        <p:spPr>
          <a:xfrm>
            <a:off x="514350" y="400050"/>
            <a:ext cx="308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3A. p-AMPK, AMPK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F9F7713F-8E69-2663-F8CE-A13B43ACD5FE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59962" y="3792668"/>
            <a:ext cx="3086100" cy="82536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5BD2AB8-5750-C631-478F-F865811DBB3D}"/>
              </a:ext>
            </a:extLst>
          </p:cNvPr>
          <p:cNvSpPr txBox="1"/>
          <p:nvPr/>
        </p:nvSpPr>
        <p:spPr>
          <a:xfrm>
            <a:off x="743204" y="3959127"/>
            <a:ext cx="941398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62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653D983-EB39-1A5E-E8AD-74A5F07A4483}"/>
              </a:ext>
            </a:extLst>
          </p:cNvPr>
          <p:cNvSpPr txBox="1"/>
          <p:nvPr/>
        </p:nvSpPr>
        <p:spPr>
          <a:xfrm>
            <a:off x="743204" y="2819110"/>
            <a:ext cx="941398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62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EC7EE888-8318-8FCF-F905-3FFC88782448}"/>
              </a:ext>
            </a:extLst>
          </p:cNvPr>
          <p:cNvCxnSpPr>
            <a:cxnSpLocks/>
          </p:cNvCxnSpPr>
          <p:nvPr/>
        </p:nvCxnSpPr>
        <p:spPr>
          <a:xfrm>
            <a:off x="2178457" y="257880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CD14338-DE78-A7C7-9DBB-B173131880BA}"/>
              </a:ext>
            </a:extLst>
          </p:cNvPr>
          <p:cNvSpPr txBox="1"/>
          <p:nvPr/>
        </p:nvSpPr>
        <p:spPr>
          <a:xfrm>
            <a:off x="2277113" y="2314474"/>
            <a:ext cx="52268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4562B2B-C120-4873-5B5C-05C93086E244}"/>
              </a:ext>
            </a:extLst>
          </p:cNvPr>
          <p:cNvSpPr txBox="1"/>
          <p:nvPr/>
        </p:nvSpPr>
        <p:spPr>
          <a:xfrm>
            <a:off x="2962693" y="2314474"/>
            <a:ext cx="7326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B0FC6F5-7DDD-5436-21AC-551006E9C02C}"/>
              </a:ext>
            </a:extLst>
          </p:cNvPr>
          <p:cNvSpPr txBox="1"/>
          <p:nvPr/>
        </p:nvSpPr>
        <p:spPr>
          <a:xfrm>
            <a:off x="3842536" y="2307457"/>
            <a:ext cx="522687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CF9AD67-3DE2-6112-68F7-F7FE14AA1292}"/>
              </a:ext>
            </a:extLst>
          </p:cNvPr>
          <p:cNvSpPr txBox="1"/>
          <p:nvPr/>
        </p:nvSpPr>
        <p:spPr>
          <a:xfrm>
            <a:off x="2575749" y="1987945"/>
            <a:ext cx="1481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elphinidin (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B79D06E-0CEF-B6B4-4489-A7DA54DED5F4}"/>
              </a:ext>
            </a:extLst>
          </p:cNvPr>
          <p:cNvCxnSpPr>
            <a:cxnSpLocks/>
          </p:cNvCxnSpPr>
          <p:nvPr/>
        </p:nvCxnSpPr>
        <p:spPr>
          <a:xfrm>
            <a:off x="2968993" y="257880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D557EF8B-6D90-4A57-E72E-B92FD38872EF}"/>
              </a:ext>
            </a:extLst>
          </p:cNvPr>
          <p:cNvCxnSpPr>
            <a:cxnSpLocks/>
          </p:cNvCxnSpPr>
          <p:nvPr/>
        </p:nvCxnSpPr>
        <p:spPr>
          <a:xfrm>
            <a:off x="3743880" y="257880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D232FF8E-9C70-264D-2DED-602BCBE8639B}"/>
              </a:ext>
            </a:extLst>
          </p:cNvPr>
          <p:cNvCxnSpPr>
            <a:cxnSpLocks/>
          </p:cNvCxnSpPr>
          <p:nvPr/>
        </p:nvCxnSpPr>
        <p:spPr>
          <a:xfrm>
            <a:off x="2390236" y="2269217"/>
            <a:ext cx="18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28167D9-4C48-19A1-CA9B-1EC83494DE67}"/>
              </a:ext>
            </a:extLst>
          </p:cNvPr>
          <p:cNvSpPr txBox="1"/>
          <p:nvPr/>
        </p:nvSpPr>
        <p:spPr>
          <a:xfrm>
            <a:off x="5871438" y="3808481"/>
            <a:ext cx="341985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ta were analyzed using three representative samples excluding outliers.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 descr="櫛 が含まれている画像&#10;&#10;自動的に生成された説明">
            <a:extLst>
              <a:ext uri="{FF2B5EF4-FFF2-40B4-BE49-F238E27FC236}">
                <a16:creationId xmlns:a16="http://schemas.microsoft.com/office/drawing/2014/main" id="{09203E14-90F5-6F7A-1AF3-889F5493E166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882829" y="2795766"/>
            <a:ext cx="2916000" cy="6821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41304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95FAFC13-B337-B693-6EDF-F243179570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4613" y="3710231"/>
            <a:ext cx="2667998" cy="8280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AFA39E65-E7C4-CA48-80C8-266BA131F3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7754" y="2667241"/>
            <a:ext cx="2368075" cy="76175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4E3EE3B-57CB-1B65-EA9E-843F03015DDC}"/>
              </a:ext>
            </a:extLst>
          </p:cNvPr>
          <p:cNvSpPr txBox="1"/>
          <p:nvPr/>
        </p:nvSpPr>
        <p:spPr>
          <a:xfrm>
            <a:off x="743204" y="3959127"/>
            <a:ext cx="941398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62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5A9CFA6-31A7-E79F-C041-2FD905297430}"/>
              </a:ext>
            </a:extLst>
          </p:cNvPr>
          <p:cNvSpPr txBox="1"/>
          <p:nvPr/>
        </p:nvSpPr>
        <p:spPr>
          <a:xfrm>
            <a:off x="743204" y="2819110"/>
            <a:ext cx="941398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62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920C9D2-4C5A-5B61-6618-B3C40DEDE33F}"/>
              </a:ext>
            </a:extLst>
          </p:cNvPr>
          <p:cNvSpPr txBox="1"/>
          <p:nvPr/>
        </p:nvSpPr>
        <p:spPr>
          <a:xfrm>
            <a:off x="2430728" y="1944143"/>
            <a:ext cx="76003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C5F6F47-24EF-16EA-6F59-0A8E9DB8DE2A}"/>
              </a:ext>
            </a:extLst>
          </p:cNvPr>
          <p:cNvSpPr txBox="1"/>
          <p:nvPr/>
        </p:nvSpPr>
        <p:spPr>
          <a:xfrm>
            <a:off x="3323909" y="1942440"/>
            <a:ext cx="1224039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ompound 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DB8ED492-B487-1B69-09ED-EE98441E8444}"/>
              </a:ext>
            </a:extLst>
          </p:cNvPr>
          <p:cNvCxnSpPr>
            <a:cxnSpLocks/>
          </p:cNvCxnSpPr>
          <p:nvPr/>
        </p:nvCxnSpPr>
        <p:spPr>
          <a:xfrm>
            <a:off x="3408474" y="2267514"/>
            <a:ext cx="102205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3680148D-A0FC-3685-CB52-0D9E37F26F53}"/>
              </a:ext>
            </a:extLst>
          </p:cNvPr>
          <p:cNvCxnSpPr>
            <a:cxnSpLocks/>
          </p:cNvCxnSpPr>
          <p:nvPr/>
        </p:nvCxnSpPr>
        <p:spPr>
          <a:xfrm>
            <a:off x="2283290" y="2263241"/>
            <a:ext cx="102205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D50F7D4-19F4-CB58-6BB4-F84EF9313B9C}"/>
              </a:ext>
            </a:extLst>
          </p:cNvPr>
          <p:cNvSpPr txBox="1"/>
          <p:nvPr/>
        </p:nvSpPr>
        <p:spPr>
          <a:xfrm>
            <a:off x="648783" y="2314473"/>
            <a:ext cx="1481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elphinidin (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1A146C94-0AD9-CCAC-0190-BEE6ED8FAF50}"/>
              </a:ext>
            </a:extLst>
          </p:cNvPr>
          <p:cNvGrpSpPr/>
          <p:nvPr/>
        </p:nvGrpSpPr>
        <p:grpSpPr>
          <a:xfrm>
            <a:off x="2265198" y="2314474"/>
            <a:ext cx="1074467" cy="276999"/>
            <a:chOff x="2265198" y="2314474"/>
            <a:chExt cx="1074467" cy="276999"/>
          </a:xfrm>
        </p:grpSpPr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3A5ACFC8-B549-063D-B13D-04545EDF3A50}"/>
                </a:ext>
              </a:extLst>
            </p:cNvPr>
            <p:cNvCxnSpPr>
              <a:cxnSpLocks/>
            </p:cNvCxnSpPr>
            <p:nvPr/>
          </p:nvCxnSpPr>
          <p:spPr>
            <a:xfrm>
              <a:off x="2265198" y="2578808"/>
              <a:ext cx="49176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6E01872-BC8F-94A3-F905-92BE87D9D4DB}"/>
                </a:ext>
              </a:extLst>
            </p:cNvPr>
            <p:cNvSpPr txBox="1"/>
            <p:nvPr/>
          </p:nvSpPr>
          <p:spPr>
            <a:xfrm>
              <a:off x="2332580" y="2314474"/>
              <a:ext cx="357004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75771C2-425C-6938-6363-6CB76FE076DC}"/>
                </a:ext>
              </a:extLst>
            </p:cNvPr>
            <p:cNvSpPr txBox="1"/>
            <p:nvPr/>
          </p:nvSpPr>
          <p:spPr>
            <a:xfrm>
              <a:off x="2915279" y="2314474"/>
              <a:ext cx="35700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1C4381A2-6280-B367-8AAD-8135C721C492}"/>
                </a:ext>
              </a:extLst>
            </p:cNvPr>
            <p:cNvCxnSpPr>
              <a:cxnSpLocks/>
            </p:cNvCxnSpPr>
            <p:nvPr/>
          </p:nvCxnSpPr>
          <p:spPr>
            <a:xfrm>
              <a:off x="2847896" y="2573160"/>
              <a:ext cx="49176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F86432B7-3253-BB89-034B-D010DB165564}"/>
              </a:ext>
            </a:extLst>
          </p:cNvPr>
          <p:cNvGrpSpPr/>
          <p:nvPr/>
        </p:nvGrpSpPr>
        <p:grpSpPr>
          <a:xfrm>
            <a:off x="3382269" y="2314474"/>
            <a:ext cx="1052567" cy="276999"/>
            <a:chOff x="2265198" y="2314474"/>
            <a:chExt cx="1052567" cy="276999"/>
          </a:xfrm>
        </p:grpSpPr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3FF94CA2-0591-9695-DEF3-A02A821F9A55}"/>
                </a:ext>
              </a:extLst>
            </p:cNvPr>
            <p:cNvCxnSpPr>
              <a:cxnSpLocks/>
            </p:cNvCxnSpPr>
            <p:nvPr/>
          </p:nvCxnSpPr>
          <p:spPr>
            <a:xfrm>
              <a:off x="2265198" y="2578808"/>
              <a:ext cx="49176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AD3A984A-E8EF-628C-2819-2EBE76BE9EF3}"/>
                </a:ext>
              </a:extLst>
            </p:cNvPr>
            <p:cNvSpPr txBox="1"/>
            <p:nvPr/>
          </p:nvSpPr>
          <p:spPr>
            <a:xfrm>
              <a:off x="2332580" y="2314474"/>
              <a:ext cx="357004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7FB4A657-F491-DE6E-E622-02B8A427A585}"/>
                </a:ext>
              </a:extLst>
            </p:cNvPr>
            <p:cNvSpPr txBox="1"/>
            <p:nvPr/>
          </p:nvSpPr>
          <p:spPr>
            <a:xfrm>
              <a:off x="2893379" y="2314474"/>
              <a:ext cx="35700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9FFB6B55-EBCF-D06D-DA78-215C691505FA}"/>
                </a:ext>
              </a:extLst>
            </p:cNvPr>
            <p:cNvCxnSpPr>
              <a:cxnSpLocks/>
            </p:cNvCxnSpPr>
            <p:nvPr/>
          </p:nvCxnSpPr>
          <p:spPr>
            <a:xfrm>
              <a:off x="2825996" y="2573160"/>
              <a:ext cx="49176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BB082FF-E56B-A0AF-32A0-AE94A40EEBC4}"/>
              </a:ext>
            </a:extLst>
          </p:cNvPr>
          <p:cNvSpPr txBox="1"/>
          <p:nvPr/>
        </p:nvSpPr>
        <p:spPr>
          <a:xfrm>
            <a:off x="514350" y="400050"/>
            <a:ext cx="308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3D. p-AMPK, AMPK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5907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206A01-AFA0-D0ED-1577-8A2AB2C2526F}"/>
              </a:ext>
            </a:extLst>
          </p:cNvPr>
          <p:cNvSpPr txBox="1"/>
          <p:nvPr/>
        </p:nvSpPr>
        <p:spPr>
          <a:xfrm>
            <a:off x="514350" y="400050"/>
            <a:ext cx="308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A.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p-LKB1, LKB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 descr="白いバックグラウンドの前に並んでいる&#10;&#10;低い精度で自動的に生成された説明">
            <a:extLst>
              <a:ext uri="{FF2B5EF4-FFF2-40B4-BE49-F238E27FC236}">
                <a16:creationId xmlns:a16="http://schemas.microsoft.com/office/drawing/2014/main" id="{3834C41B-902F-3F17-63B8-FC66272920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866900" y="2745031"/>
            <a:ext cx="3086100" cy="702564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B7FD8B5-4AD7-7264-4EB1-39C0E636F6A8}"/>
              </a:ext>
            </a:extLst>
          </p:cNvPr>
          <p:cNvSpPr txBox="1"/>
          <p:nvPr/>
        </p:nvSpPr>
        <p:spPr>
          <a:xfrm>
            <a:off x="743204" y="3607326"/>
            <a:ext cx="941398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LKB1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54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0EFF765-D399-2D4F-466F-2F8C0836225C}"/>
              </a:ext>
            </a:extLst>
          </p:cNvPr>
          <p:cNvSpPr txBox="1"/>
          <p:nvPr/>
        </p:nvSpPr>
        <p:spPr>
          <a:xfrm>
            <a:off x="743204" y="2745031"/>
            <a:ext cx="941398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-LKB1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54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 descr="櫛 が含まれている画像&#10;&#10;自動的に生成された説明">
            <a:extLst>
              <a:ext uri="{FF2B5EF4-FFF2-40B4-BE49-F238E27FC236}">
                <a16:creationId xmlns:a16="http://schemas.microsoft.com/office/drawing/2014/main" id="{F06F8E09-A30D-C9C8-17A5-FB4B63A9BE4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67162" y="3607326"/>
            <a:ext cx="3185838" cy="702564"/>
          </a:xfrm>
          <a:prstGeom prst="rect">
            <a:avLst/>
          </a:prstGeom>
        </p:spPr>
      </p:pic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E3BE0454-0995-7FE7-CCC2-438C289F4C0B}"/>
              </a:ext>
            </a:extLst>
          </p:cNvPr>
          <p:cNvCxnSpPr>
            <a:cxnSpLocks/>
          </p:cNvCxnSpPr>
          <p:nvPr/>
        </p:nvCxnSpPr>
        <p:spPr>
          <a:xfrm>
            <a:off x="2327682" y="268040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5E86B1D-A8EE-38B5-C6EB-677F85EC51FE}"/>
              </a:ext>
            </a:extLst>
          </p:cNvPr>
          <p:cNvSpPr txBox="1"/>
          <p:nvPr/>
        </p:nvSpPr>
        <p:spPr>
          <a:xfrm>
            <a:off x="2426338" y="2416074"/>
            <a:ext cx="52268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701DDD2-D3CD-376F-2C05-9648D6496549}"/>
              </a:ext>
            </a:extLst>
          </p:cNvPr>
          <p:cNvSpPr txBox="1"/>
          <p:nvPr/>
        </p:nvSpPr>
        <p:spPr>
          <a:xfrm>
            <a:off x="3111918" y="2416074"/>
            <a:ext cx="7326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25C13DB5-EFFB-893F-6484-B75E909F906F}"/>
              </a:ext>
            </a:extLst>
          </p:cNvPr>
          <p:cNvSpPr txBox="1"/>
          <p:nvPr/>
        </p:nvSpPr>
        <p:spPr>
          <a:xfrm>
            <a:off x="3991761" y="2409057"/>
            <a:ext cx="522687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8519E4E6-49E0-9BBB-4FD1-586CC9804EF5}"/>
              </a:ext>
            </a:extLst>
          </p:cNvPr>
          <p:cNvSpPr txBox="1"/>
          <p:nvPr/>
        </p:nvSpPr>
        <p:spPr>
          <a:xfrm>
            <a:off x="2724974" y="2089545"/>
            <a:ext cx="1481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elphinidin (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A0E74DE7-1F18-F59C-388E-4EA1FD98F8CD}"/>
              </a:ext>
            </a:extLst>
          </p:cNvPr>
          <p:cNvCxnSpPr>
            <a:cxnSpLocks/>
          </p:cNvCxnSpPr>
          <p:nvPr/>
        </p:nvCxnSpPr>
        <p:spPr>
          <a:xfrm>
            <a:off x="3118218" y="268040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3C33B29B-31C9-F56B-05B9-C47682FF8FFF}"/>
              </a:ext>
            </a:extLst>
          </p:cNvPr>
          <p:cNvCxnSpPr>
            <a:cxnSpLocks/>
          </p:cNvCxnSpPr>
          <p:nvPr/>
        </p:nvCxnSpPr>
        <p:spPr>
          <a:xfrm>
            <a:off x="3893105" y="2680408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96719008-A55E-C90D-6DB0-01298676756D}"/>
              </a:ext>
            </a:extLst>
          </p:cNvPr>
          <p:cNvCxnSpPr>
            <a:cxnSpLocks/>
          </p:cNvCxnSpPr>
          <p:nvPr/>
        </p:nvCxnSpPr>
        <p:spPr>
          <a:xfrm>
            <a:off x="2539461" y="2370817"/>
            <a:ext cx="18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A79CE05-49D9-403D-C165-4B184D97E8DA}"/>
              </a:ext>
            </a:extLst>
          </p:cNvPr>
          <p:cNvSpPr txBox="1"/>
          <p:nvPr/>
        </p:nvSpPr>
        <p:spPr>
          <a:xfrm>
            <a:off x="5871438" y="3808481"/>
            <a:ext cx="341985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ta were analyzed using three representative samples excluding outliers.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56794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D9A5C3F-C86B-CE6A-8597-4995CD79BA18}"/>
              </a:ext>
            </a:extLst>
          </p:cNvPr>
          <p:cNvSpPr txBox="1"/>
          <p:nvPr/>
        </p:nvSpPr>
        <p:spPr>
          <a:xfrm>
            <a:off x="671694" y="4347772"/>
            <a:ext cx="968741" cy="4924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kumimoji="1" lang="en-US" altLang="ja-JP" sz="14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42 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BA5C69AF-DDAC-04EA-8E0F-E0309C8F6F7A}"/>
              </a:ext>
            </a:extLst>
          </p:cNvPr>
          <p:cNvGrpSpPr/>
          <p:nvPr/>
        </p:nvGrpSpPr>
        <p:grpSpPr>
          <a:xfrm>
            <a:off x="548817" y="3410924"/>
            <a:ext cx="4661358" cy="822960"/>
            <a:chOff x="548817" y="2606040"/>
            <a:chExt cx="4661358" cy="822960"/>
          </a:xfrm>
        </p:grpSpPr>
        <p:pic>
          <p:nvPicPr>
            <p:cNvPr id="6" name="図 5" descr="水, 飛行機, 鳥 が含まれている画像&#10;&#10;自動的に生成された説明">
              <a:extLst>
                <a:ext uri="{FF2B5EF4-FFF2-40B4-BE49-F238E27FC236}">
                  <a16:creationId xmlns:a16="http://schemas.microsoft.com/office/drawing/2014/main" id="{2A4452D9-023C-4C47-CA28-2F5E47C7C5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43113" y="2606040"/>
              <a:ext cx="3167062" cy="822960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10AAD301-8B60-DFD5-4907-45A7C21AA2B8}"/>
                </a:ext>
              </a:extLst>
            </p:cNvPr>
            <p:cNvSpPr txBox="1"/>
            <p:nvPr/>
          </p:nvSpPr>
          <p:spPr>
            <a:xfrm>
              <a:off x="548817" y="2636818"/>
              <a:ext cx="1091618" cy="492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aMKK2</a:t>
              </a:r>
            </a:p>
            <a:p>
              <a:pPr algn="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65 </a:t>
              </a:r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56A86518-34AE-A3E5-7B22-C979DFBB9284}"/>
              </a:ext>
            </a:extLst>
          </p:cNvPr>
          <p:cNvGrpSpPr/>
          <p:nvPr/>
        </p:nvGrpSpPr>
        <p:grpSpPr>
          <a:xfrm>
            <a:off x="548817" y="2504854"/>
            <a:ext cx="4661358" cy="822961"/>
            <a:chOff x="548817" y="1474342"/>
            <a:chExt cx="4661358" cy="822961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247CC854-CACF-7CCD-DA53-7605EDB4D0AC}"/>
                </a:ext>
              </a:extLst>
            </p:cNvPr>
            <p:cNvSpPr txBox="1"/>
            <p:nvPr/>
          </p:nvSpPr>
          <p:spPr>
            <a:xfrm>
              <a:off x="548817" y="1505120"/>
              <a:ext cx="1091618" cy="4924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RF1</a:t>
              </a:r>
            </a:p>
            <a:p>
              <a:pPr algn="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68 </a:t>
              </a:r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図 9" descr="白いバックグラウンドの前に並んでいる&#10;&#10;低い精度で自動的に生成された説明">
              <a:extLst>
                <a:ext uri="{FF2B5EF4-FFF2-40B4-BE49-F238E27FC236}">
                  <a16:creationId xmlns:a16="http://schemas.microsoft.com/office/drawing/2014/main" id="{855F9F29-EBBD-D315-B466-89E4DA8C68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43113" y="1474342"/>
              <a:ext cx="3167062" cy="822961"/>
            </a:xfrm>
            <a:prstGeom prst="rect">
              <a:avLst/>
            </a:prstGeom>
          </p:spPr>
        </p:pic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6FF6A6A-4D3A-CDC2-C93B-00710FDF416B}"/>
              </a:ext>
            </a:extLst>
          </p:cNvPr>
          <p:cNvSpPr txBox="1"/>
          <p:nvPr/>
        </p:nvSpPr>
        <p:spPr>
          <a:xfrm>
            <a:off x="514350" y="400050"/>
            <a:ext cx="308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B. NRF1, CaMKK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4E4B439D-17C9-872F-2ECE-500C7E96716F}"/>
              </a:ext>
            </a:extLst>
          </p:cNvPr>
          <p:cNvCxnSpPr>
            <a:cxnSpLocks/>
          </p:cNvCxnSpPr>
          <p:nvPr/>
        </p:nvCxnSpPr>
        <p:spPr>
          <a:xfrm>
            <a:off x="2556282" y="2526645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5693FC5-C4D0-E713-D892-E525171B9B80}"/>
              </a:ext>
            </a:extLst>
          </p:cNvPr>
          <p:cNvSpPr txBox="1"/>
          <p:nvPr/>
        </p:nvSpPr>
        <p:spPr>
          <a:xfrm>
            <a:off x="2654938" y="2262311"/>
            <a:ext cx="52268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EC992BA-0BF0-A78F-67E2-4E0881CD0D19}"/>
              </a:ext>
            </a:extLst>
          </p:cNvPr>
          <p:cNvSpPr txBox="1"/>
          <p:nvPr/>
        </p:nvSpPr>
        <p:spPr>
          <a:xfrm>
            <a:off x="3340518" y="2262311"/>
            <a:ext cx="73260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0627B4C-0459-C6CE-5BD3-527FA5F65086}"/>
              </a:ext>
            </a:extLst>
          </p:cNvPr>
          <p:cNvSpPr txBox="1"/>
          <p:nvPr/>
        </p:nvSpPr>
        <p:spPr>
          <a:xfrm>
            <a:off x="4220361" y="2255294"/>
            <a:ext cx="522687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D00BDCF-3EF4-F641-6E84-26D26A1033F8}"/>
              </a:ext>
            </a:extLst>
          </p:cNvPr>
          <p:cNvSpPr txBox="1"/>
          <p:nvPr/>
        </p:nvSpPr>
        <p:spPr>
          <a:xfrm>
            <a:off x="2953574" y="1935782"/>
            <a:ext cx="1481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elphinidin (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4FC5045C-A2AB-977A-0811-AED7627DF0B5}"/>
              </a:ext>
            </a:extLst>
          </p:cNvPr>
          <p:cNvCxnSpPr>
            <a:cxnSpLocks/>
          </p:cNvCxnSpPr>
          <p:nvPr/>
        </p:nvCxnSpPr>
        <p:spPr>
          <a:xfrm>
            <a:off x="3346818" y="2526645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E8D26260-6AB8-131D-4252-93230E083763}"/>
              </a:ext>
            </a:extLst>
          </p:cNvPr>
          <p:cNvCxnSpPr>
            <a:cxnSpLocks/>
          </p:cNvCxnSpPr>
          <p:nvPr/>
        </p:nvCxnSpPr>
        <p:spPr>
          <a:xfrm>
            <a:off x="4121705" y="2526645"/>
            <a:ext cx="72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792EF175-2869-6C33-D95E-7B6D607A25EA}"/>
              </a:ext>
            </a:extLst>
          </p:cNvPr>
          <p:cNvCxnSpPr>
            <a:cxnSpLocks/>
          </p:cNvCxnSpPr>
          <p:nvPr/>
        </p:nvCxnSpPr>
        <p:spPr>
          <a:xfrm>
            <a:off x="2768061" y="2217054"/>
            <a:ext cx="1800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85858B4-BCEA-8584-5162-53F9B3012E6B}"/>
              </a:ext>
            </a:extLst>
          </p:cNvPr>
          <p:cNvSpPr txBox="1"/>
          <p:nvPr/>
        </p:nvSpPr>
        <p:spPr>
          <a:xfrm>
            <a:off x="5871438" y="3808481"/>
            <a:ext cx="341985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ta were analyzed using three representative samples excluding outliers.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75539A1-2E4B-FEAE-DDCE-2D09261A83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98991" y="4311827"/>
            <a:ext cx="3255306" cy="7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2685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17</TotalTime>
  <Words>173</Words>
  <Application>Microsoft Macintosh PowerPoint</Application>
  <PresentationFormat>A4 210 x 297 mm</PresentationFormat>
  <Paragraphs>56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Rina</dc:creator>
  <cp:lastModifiedBy>MURATA Motoki</cp:lastModifiedBy>
  <cp:revision>33</cp:revision>
  <dcterms:created xsi:type="dcterms:W3CDTF">2023-09-29T04:07:40Z</dcterms:created>
  <dcterms:modified xsi:type="dcterms:W3CDTF">2024-10-23T00:15:49Z</dcterms:modified>
</cp:coreProperties>
</file>